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288588" cy="6858000"/>
  <p:notesSz cx="9867900" cy="67357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867600" cy="6735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59080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3024000" y="523440"/>
            <a:ext cx="3817800" cy="25448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59080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07324A-2D91-4760-A050-9D51CFE18D89}" type="slidenum">
              <a: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3024360" y="523800"/>
            <a:ext cx="3817800" cy="254484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スライド番号プレースホルダー 3"/>
          <p:cNvSpPr/>
          <p:nvPr/>
        </p:nvSpPr>
        <p:spPr>
          <a:xfrm>
            <a:off x="55911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5F071F-B13A-4D44-8DCE-F1E41266669F}" type="slidenum">
              <a:rPr b="1" lang="en-US" sz="1200" spc="-1" strike="noStrike">
                <a:solidFill>
                  <a:srgbClr val="ffffff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97E24-94C7-45A9-B37A-D665A0E4D7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1F370-88C5-4A34-996A-059AE6A972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73FF3-AB61-4EA9-B173-DF3B58B33D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72744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8376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7112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72744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8376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9B3A7-AB1C-4C74-AE9B-F2EDE68DB2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28641-7971-461D-8FF5-3E57276955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20952-047D-41F5-87D8-489D816F59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3B8FE3-D05E-4FC6-BFB4-235767E35B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448B1C-260F-4B63-AF63-A981E9EF71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71120" y="609120"/>
            <a:ext cx="874404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82BE2-B810-4350-AC77-7B5560A827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E72BDF-3861-4D4E-9C06-F5FE43E33C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02786-F26A-46B4-AC59-0E8E0D4581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8CBFB-862A-4E3C-8129-E885095B72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7112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514320" y="6248520"/>
            <a:ext cx="32576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37208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  <a:ea typeface="Osak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5A02FA-2421-496F-ADF4-30440C2362E9}" type="slidenum">
              <a:rPr b="0" lang="en-US" sz="1400" spc="-1" strike="noStrike">
                <a:solidFill>
                  <a:srgbClr val="ffffff"/>
                </a:solidFill>
                <a:latin typeface="Times New Roman"/>
                <a:ea typeface="Osaka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1"/>
          <p:cNvGrpSpPr/>
          <p:nvPr/>
        </p:nvGrpSpPr>
        <p:grpSpPr>
          <a:xfrm>
            <a:off x="-30240" y="52560"/>
            <a:ext cx="11031840" cy="6647400"/>
            <a:chOff x="-30240" y="52560"/>
            <a:chExt cx="11031840" cy="6647400"/>
          </a:xfrm>
        </p:grpSpPr>
        <p:sp>
          <p:nvSpPr>
            <p:cNvPr id="49" name="Text Box 27"/>
            <p:cNvSpPr/>
            <p:nvPr/>
          </p:nvSpPr>
          <p:spPr>
            <a:xfrm>
              <a:off x="463680" y="52560"/>
              <a:ext cx="10537920" cy="580680"/>
            </a:xfrm>
            <a:prstGeom prst="rect">
              <a:avLst/>
            </a:prstGeom>
            <a:noFill/>
            <a:ln w="0">
              <a:noFill/>
            </a:ln>
            <a:effectLst>
              <a:outerShdw dist="17819" dir="2700000" blurRad="0" rotWithShape="0">
                <a:srgbClr val="00003d">
                  <a:alpha val="7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Demographic and pathological characteristics of 51 male patients 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undergoing anterior urethra sparing cystoprostatectomy and simultaneous urinary diversion for bladder UC 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0" name="Line 28"/>
            <p:cNvSpPr/>
            <p:nvPr/>
          </p:nvSpPr>
          <p:spPr>
            <a:xfrm>
              <a:off x="0" y="6272280"/>
              <a:ext cx="10287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1" name="Line 33"/>
            <p:cNvSpPr/>
            <p:nvPr/>
          </p:nvSpPr>
          <p:spPr>
            <a:xfrm>
              <a:off x="-30240" y="700200"/>
              <a:ext cx="10287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2" name="Line 34"/>
            <p:cNvSpPr/>
            <p:nvPr/>
          </p:nvSpPr>
          <p:spPr>
            <a:xfrm>
              <a:off x="12600" y="1481040"/>
              <a:ext cx="10287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3" name="Rectangle 55"/>
            <p:cNvSpPr/>
            <p:nvPr/>
          </p:nvSpPr>
          <p:spPr>
            <a:xfrm>
              <a:off x="31320" y="246240"/>
              <a:ext cx="1034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Table S1.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4" name="Text Box 25"/>
            <p:cNvSpPr/>
            <p:nvPr/>
          </p:nvSpPr>
          <p:spPr>
            <a:xfrm>
              <a:off x="48960" y="1494000"/>
              <a:ext cx="4991040" cy="4717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o. pts (</a:t>
              </a:r>
              <a:r>
                <a:rPr b="0" lang="ja-JP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Median age (range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Median months follow up (range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o. CIS (</a:t>
              </a:r>
              <a:r>
                <a:rPr b="0" lang="ja-JP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o. Pathological stgage (</a:t>
              </a:r>
              <a:r>
                <a:rPr b="0" lang="ja-JP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　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Ta/Tis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T1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T2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T3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T4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o. Lymph node positive (</a:t>
              </a:r>
              <a:r>
                <a:rPr b="0" lang="ja-JP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o. UC grade (</a:t>
              </a:r>
              <a:r>
                <a:rPr b="0" lang="ja-JP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o. prostate involvement (</a:t>
              </a:r>
              <a:r>
                <a:rPr b="0" lang="ja-JP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)</a:t>
              </a:r>
              <a:r>
                <a:rPr b="0" lang="ja-JP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：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Superficial (includes prostatic urethra &amp; duct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Invasive (into prostatic stroma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one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5" name="Text Box 26"/>
            <p:cNvSpPr/>
            <p:nvPr/>
          </p:nvSpPr>
          <p:spPr>
            <a:xfrm>
              <a:off x="4390920" y="1500120"/>
              <a:ext cx="1118880" cy="4717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51 (100</a:t>
              </a:r>
              <a:r>
                <a:rPr b="0" lang="ja-JP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）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66 (48-84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5 (4-143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0 (19.6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7 (13.7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2 (23.6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3 (25.4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4 (27.5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5 (9.8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9 (17.6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9 (37.3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2 (62.8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2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 (5.9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7 (92.2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6" name="Line 40"/>
            <p:cNvSpPr/>
            <p:nvPr/>
          </p:nvSpPr>
          <p:spPr>
            <a:xfrm>
              <a:off x="5362560" y="1071720"/>
              <a:ext cx="3078000" cy="126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7" name="Rectangle 42"/>
            <p:cNvSpPr/>
            <p:nvPr/>
          </p:nvSpPr>
          <p:spPr>
            <a:xfrm>
              <a:off x="8958600" y="930240"/>
              <a:ext cx="878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 </a:t>
              </a: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Value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8" name="Text Box 43"/>
            <p:cNvSpPr/>
            <p:nvPr/>
          </p:nvSpPr>
          <p:spPr>
            <a:xfrm>
              <a:off x="8991720" y="1495440"/>
              <a:ext cx="722160" cy="520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664.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228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425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759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951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237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290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186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717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-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508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639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312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552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826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9" name="Rectangle 46"/>
            <p:cNvSpPr/>
            <p:nvPr/>
          </p:nvSpPr>
          <p:spPr>
            <a:xfrm>
              <a:off x="4390920" y="909720"/>
              <a:ext cx="804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Total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0" name="Rectangle 48"/>
            <p:cNvSpPr/>
            <p:nvPr/>
          </p:nvSpPr>
          <p:spPr>
            <a:xfrm>
              <a:off x="6513480" y="725400"/>
              <a:ext cx="12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Diversion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1" name="Rectangle 49"/>
            <p:cNvSpPr/>
            <p:nvPr/>
          </p:nvSpPr>
          <p:spPr>
            <a:xfrm>
              <a:off x="5852520" y="1116000"/>
              <a:ext cx="377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IC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2" name="Rectangle 51"/>
            <p:cNvSpPr/>
            <p:nvPr/>
          </p:nvSpPr>
          <p:spPr>
            <a:xfrm>
              <a:off x="31320" y="903240"/>
              <a:ext cx="87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Factors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3" name="Text Box 56"/>
            <p:cNvSpPr/>
            <p:nvPr/>
          </p:nvSpPr>
          <p:spPr>
            <a:xfrm>
              <a:off x="5865840" y="1495440"/>
              <a:ext cx="1093680" cy="520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5 (49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69 (48-84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7 (4-134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7.8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 (12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6 (24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16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8 (32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16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5 (20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1 (44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4 (56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4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 (8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2 (88.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4" name="Rectangle 49"/>
            <p:cNvSpPr/>
            <p:nvPr/>
          </p:nvSpPr>
          <p:spPr>
            <a:xfrm>
              <a:off x="7283880" y="1116000"/>
              <a:ext cx="465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B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5" name="Text Box 56"/>
            <p:cNvSpPr/>
            <p:nvPr/>
          </p:nvSpPr>
          <p:spPr>
            <a:xfrm>
              <a:off x="7304040" y="1495440"/>
              <a:ext cx="1131840" cy="4717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6 (51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65 (52-78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52 (6-143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6 (11.8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15.4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6 (23.1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9 (34.6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6 (23.1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3.8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15.4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8 (30.8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8 (69.2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3.8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5 (96.2)</a:t>
              </a:r>
              <a:endParaRPr b="1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0-05-10T06:54:23Z</dcterms:created>
  <dc:creator>pal</dc:creator>
  <dc:description/>
  <dc:language>en-US</dc:language>
  <cp:lastModifiedBy>NOZOMI HAYAKAWA</cp:lastModifiedBy>
  <cp:lastPrinted>2015-01-22T06:15:28Z</cp:lastPrinted>
  <dcterms:modified xsi:type="dcterms:W3CDTF">2015-08-05T00:30:54Z</dcterms:modified>
  <cp:revision>938</cp:revision>
  <dc:subject/>
  <dc:title>1501043</dc:title>
</cp:coreProperties>
</file>